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1170" autoAdjust="0"/>
  </p:normalViewPr>
  <p:slideViewPr>
    <p:cSldViewPr snapToGrid="0">
      <p:cViewPr varScale="1">
        <p:scale>
          <a:sx n="46" d="100"/>
          <a:sy n="46" d="100"/>
        </p:scale>
        <p:origin x="2109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778F1-FFED-4DFB-B6B2-08E8FAA881F7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E7C6F-1E25-4137-B868-A760EAB1E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159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EE7C6F-1E25-4137-B868-A760EAB1E2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6096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48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73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912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174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65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49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34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627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562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634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397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5D9A2-B731-4831-B310-3D744F26E69F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310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6774" y="454409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580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556458" y="871843"/>
            <a:ext cx="187551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=27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=18 infants unstable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=22 infants died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6772" y="1695636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513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56458" y="2142526"/>
            <a:ext cx="177425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=28 declin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46772" y="2592558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485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Elbow Connector 12"/>
          <p:cNvCxnSpPr>
            <a:stCxn id="2" idx="2"/>
            <a:endCxn id="4" idx="1"/>
          </p:cNvCxnSpPr>
          <p:nvPr/>
        </p:nvCxnSpPr>
        <p:spPr>
          <a:xfrm rot="16200000" flipH="1">
            <a:off x="1243162" y="881712"/>
            <a:ext cx="463601" cy="16299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2" idx="2"/>
            <a:endCxn id="6" idx="0"/>
          </p:cNvCxnSpPr>
          <p:nvPr/>
        </p:nvCxnSpPr>
        <p:spPr>
          <a:xfrm flipH="1">
            <a:off x="1393465" y="731408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lbow Connector 16"/>
          <p:cNvCxnSpPr>
            <a:stCxn id="6" idx="2"/>
            <a:endCxn id="9" idx="1"/>
          </p:cNvCxnSpPr>
          <p:nvPr/>
        </p:nvCxnSpPr>
        <p:spPr>
          <a:xfrm rot="16200000" flipH="1">
            <a:off x="1320766" y="2045333"/>
            <a:ext cx="308391" cy="162993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6" idx="2"/>
            <a:endCxn id="10" idx="0"/>
          </p:cNvCxnSpPr>
          <p:nvPr/>
        </p:nvCxnSpPr>
        <p:spPr>
          <a:xfrm>
            <a:off x="1393465" y="1972635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3926177" y="454409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60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850947" y="870136"/>
            <a:ext cx="18673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43 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unstabl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died 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926175" y="1695636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15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850947" y="2140819"/>
            <a:ext cx="171340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cline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926175" y="2592558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05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Elbow Connector 39"/>
          <p:cNvCxnSpPr>
            <a:stCxn id="35" idx="2"/>
            <a:endCxn id="36" idx="1"/>
          </p:cNvCxnSpPr>
          <p:nvPr/>
        </p:nvCxnSpPr>
        <p:spPr>
          <a:xfrm rot="16200000" flipH="1">
            <a:off x="4534661" y="877016"/>
            <a:ext cx="461894" cy="170677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>
            <a:stCxn id="35" idx="2"/>
            <a:endCxn id="37" idx="0"/>
          </p:cNvCxnSpPr>
          <p:nvPr/>
        </p:nvCxnSpPr>
        <p:spPr>
          <a:xfrm flipH="1">
            <a:off x="4680268" y="731408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Elbow Connector 41"/>
          <p:cNvCxnSpPr>
            <a:stCxn id="37" idx="2"/>
            <a:endCxn id="38" idx="1"/>
          </p:cNvCxnSpPr>
          <p:nvPr/>
        </p:nvCxnSpPr>
        <p:spPr>
          <a:xfrm rot="16200000" flipH="1">
            <a:off x="4612265" y="2040637"/>
            <a:ext cx="306684" cy="170679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37" idx="2"/>
            <a:endCxn id="39" idx="0"/>
          </p:cNvCxnSpPr>
          <p:nvPr/>
        </p:nvCxnSpPr>
        <p:spPr>
          <a:xfrm>
            <a:off x="4680268" y="1972635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372909" y="76414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ingstone - Hospita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659711" y="76414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ingstone - UHC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46774" y="3510927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78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556458" y="3928361"/>
            <a:ext cx="187551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5 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 infa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stabl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 infant di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46772" y="4752154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70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556458" y="5199044"/>
            <a:ext cx="177425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7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clines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646772" y="5649076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63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Elbow Connector 87"/>
          <p:cNvCxnSpPr>
            <a:stCxn id="83" idx="2"/>
            <a:endCxn id="84" idx="1"/>
          </p:cNvCxnSpPr>
          <p:nvPr/>
        </p:nvCxnSpPr>
        <p:spPr>
          <a:xfrm rot="16200000" flipH="1">
            <a:off x="1243162" y="3938230"/>
            <a:ext cx="463601" cy="16299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>
            <a:stCxn id="83" idx="2"/>
            <a:endCxn id="85" idx="0"/>
          </p:cNvCxnSpPr>
          <p:nvPr/>
        </p:nvCxnSpPr>
        <p:spPr>
          <a:xfrm flipH="1">
            <a:off x="1393465" y="3787926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Elbow Connector 89"/>
          <p:cNvCxnSpPr>
            <a:stCxn id="85" idx="2"/>
            <a:endCxn id="86" idx="1"/>
          </p:cNvCxnSpPr>
          <p:nvPr/>
        </p:nvCxnSpPr>
        <p:spPr>
          <a:xfrm rot="16200000" flipH="1">
            <a:off x="1320766" y="5101851"/>
            <a:ext cx="308391" cy="162993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>
            <a:stCxn id="85" idx="2"/>
            <a:endCxn id="87" idx="0"/>
          </p:cNvCxnSpPr>
          <p:nvPr/>
        </p:nvCxnSpPr>
        <p:spPr>
          <a:xfrm>
            <a:off x="1393465" y="5029153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3926177" y="3510927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45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850947" y="3926654"/>
            <a:ext cx="18673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4 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 infa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stabl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 infa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ed 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3926175" y="4752154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9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850947" y="5197337"/>
            <a:ext cx="171340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clines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926175" y="5649076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8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Elbow Connector 96"/>
          <p:cNvCxnSpPr>
            <a:stCxn id="92" idx="2"/>
            <a:endCxn id="93" idx="1"/>
          </p:cNvCxnSpPr>
          <p:nvPr/>
        </p:nvCxnSpPr>
        <p:spPr>
          <a:xfrm rot="16200000" flipH="1">
            <a:off x="4534661" y="3933534"/>
            <a:ext cx="461894" cy="170677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>
            <a:stCxn id="92" idx="2"/>
            <a:endCxn id="94" idx="0"/>
          </p:cNvCxnSpPr>
          <p:nvPr/>
        </p:nvCxnSpPr>
        <p:spPr>
          <a:xfrm flipH="1">
            <a:off x="4680268" y="3787926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Elbow Connector 98"/>
          <p:cNvCxnSpPr>
            <a:stCxn id="94" idx="2"/>
            <a:endCxn id="95" idx="1"/>
          </p:cNvCxnSpPr>
          <p:nvPr/>
        </p:nvCxnSpPr>
        <p:spPr>
          <a:xfrm rot="16200000" flipH="1">
            <a:off x="4612265" y="5097155"/>
            <a:ext cx="306684" cy="170679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>
            <a:stCxn id="94" idx="2"/>
            <a:endCxn id="96" idx="0"/>
          </p:cNvCxnSpPr>
          <p:nvPr/>
        </p:nvCxnSpPr>
        <p:spPr>
          <a:xfrm>
            <a:off x="4680268" y="5029153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372909" y="3132932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m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 Hospita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659711" y="3132932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m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 UH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46774" y="6541263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22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556458" y="6958697"/>
            <a:ext cx="187551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43 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unstabl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died 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646772" y="7782490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56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556458" y="8229380"/>
            <a:ext cx="177425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6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clines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646772" y="8679412"/>
            <a:ext cx="14933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90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Elbow Connector 107"/>
          <p:cNvCxnSpPr>
            <a:stCxn id="103" idx="2"/>
            <a:endCxn id="104" idx="1"/>
          </p:cNvCxnSpPr>
          <p:nvPr/>
        </p:nvCxnSpPr>
        <p:spPr>
          <a:xfrm rot="16200000" flipH="1">
            <a:off x="1243162" y="6968566"/>
            <a:ext cx="463601" cy="16299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>
            <a:stCxn id="103" idx="2"/>
            <a:endCxn id="105" idx="0"/>
          </p:cNvCxnSpPr>
          <p:nvPr/>
        </p:nvCxnSpPr>
        <p:spPr>
          <a:xfrm flipH="1">
            <a:off x="1393465" y="6818262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Elbow Connector 109"/>
          <p:cNvCxnSpPr>
            <a:stCxn id="105" idx="2"/>
            <a:endCxn id="106" idx="1"/>
          </p:cNvCxnSpPr>
          <p:nvPr/>
        </p:nvCxnSpPr>
        <p:spPr>
          <a:xfrm rot="16200000" flipH="1">
            <a:off x="1320766" y="8132187"/>
            <a:ext cx="308391" cy="162993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>
            <a:stCxn id="105" idx="2"/>
            <a:endCxn id="107" idx="0"/>
          </p:cNvCxnSpPr>
          <p:nvPr/>
        </p:nvCxnSpPr>
        <p:spPr>
          <a:xfrm>
            <a:off x="1393465" y="8059489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3926177" y="6541263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42 deliveri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850947" y="6956990"/>
            <a:ext cx="186738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9 discharg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unstabl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ants died 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3926175" y="7782490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10 approach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850947" y="8227673"/>
            <a:ext cx="171340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clines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3926175" y="8679412"/>
            <a:ext cx="150818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=209 consen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Elbow Connector 116"/>
          <p:cNvCxnSpPr>
            <a:stCxn id="112" idx="2"/>
            <a:endCxn id="113" idx="1"/>
          </p:cNvCxnSpPr>
          <p:nvPr/>
        </p:nvCxnSpPr>
        <p:spPr>
          <a:xfrm rot="16200000" flipH="1">
            <a:off x="4534661" y="6963870"/>
            <a:ext cx="461894" cy="170677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>
            <a:stCxn id="112" idx="2"/>
            <a:endCxn id="114" idx="0"/>
          </p:cNvCxnSpPr>
          <p:nvPr/>
        </p:nvCxnSpPr>
        <p:spPr>
          <a:xfrm flipH="1">
            <a:off x="4680268" y="6818262"/>
            <a:ext cx="2" cy="9642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Elbow Connector 118"/>
          <p:cNvCxnSpPr>
            <a:stCxn id="114" idx="2"/>
            <a:endCxn id="115" idx="1"/>
          </p:cNvCxnSpPr>
          <p:nvPr/>
        </p:nvCxnSpPr>
        <p:spPr>
          <a:xfrm rot="16200000" flipH="1">
            <a:off x="4612265" y="8127491"/>
            <a:ext cx="306684" cy="170679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/>
          <p:cNvCxnSpPr>
            <a:stCxn id="114" idx="2"/>
            <a:endCxn id="116" idx="0"/>
          </p:cNvCxnSpPr>
          <p:nvPr/>
        </p:nvCxnSpPr>
        <p:spPr>
          <a:xfrm>
            <a:off x="4680268" y="8059489"/>
            <a:ext cx="0" cy="619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372909" y="6163268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h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Hospital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659711" y="6163268"/>
            <a:ext cx="2041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h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 RHC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3"/>
          <p:cNvCxnSpPr/>
          <p:nvPr/>
        </p:nvCxnSpPr>
        <p:spPr>
          <a:xfrm>
            <a:off x="178420" y="3055434"/>
            <a:ext cx="6475141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178420" y="6099717"/>
            <a:ext cx="6475141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6066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90</TotalTime>
  <Words>114</Words>
  <Application>Microsoft Office PowerPoint</Application>
  <PresentationFormat>On-screen Show (4:3)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cliffe, Catherine G.</dc:creator>
  <cp:lastModifiedBy>Sutcliffe, Catherine G.</cp:lastModifiedBy>
  <cp:revision>130</cp:revision>
  <dcterms:created xsi:type="dcterms:W3CDTF">2018-08-17T18:53:56Z</dcterms:created>
  <dcterms:modified xsi:type="dcterms:W3CDTF">2020-03-12T07:15:49Z</dcterms:modified>
</cp:coreProperties>
</file>